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0" r:id="rId2"/>
    <p:sldId id="271" r:id="rId3"/>
    <p:sldId id="276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94" userDrawn="1">
          <p15:clr>
            <a:srgbClr val="A4A3A4"/>
          </p15:clr>
        </p15:guide>
        <p15:guide id="2" pos="41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0" autoAdjust="0"/>
    <p:restoredTop sz="94660"/>
  </p:normalViewPr>
  <p:slideViewPr>
    <p:cSldViewPr snapToGrid="0">
      <p:cViewPr varScale="1">
        <p:scale>
          <a:sx n="95" d="100"/>
          <a:sy n="95" d="100"/>
        </p:scale>
        <p:origin x="53" y="53"/>
      </p:cViewPr>
      <p:guideLst>
        <p:guide orient="horz" pos="1094"/>
        <p:guide pos="4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5E3B53-0B9A-1642-AECB-7F0F5A82A656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56BE33-8ECF-904F-ADCC-3E8A9E09B0B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86807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97E773-5BE6-ABBC-3BEC-2366700C79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E6A705D-ED0B-3F02-7923-9CE359FFE7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C2BDD1B-1B86-C489-F3AA-6A08E5FAA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84C5423-5FA8-5EC0-D8C3-1726DEEE7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D3D914A-3D8E-34F8-18C6-39FF95156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46472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87429DE-6A33-CE92-BDC8-C6B96D42BC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9235E21-79AC-888F-0C42-D99545114F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A43E1B2-DBE7-7EB6-4180-CB03DB525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12D510E-CCF2-DEFB-A70E-19482CFBA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ACA53C1-C53C-36E0-4BD3-1F3E09DC7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4754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FEE0810-2444-8757-358B-1F4D111691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99D4280-DD7F-0EED-3590-3C44FFE4E8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65C435E-2FB2-5BCF-8F1A-A5EED236D5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25D618B-9EC7-C730-EE75-7918F5BCB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7936697-31B0-F78B-A39D-D70635EEA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5231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DE80139-C48D-8462-C205-586B6C1A9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1AEC55C-9CD2-C5AB-CFA8-5EEF2F8FC2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729CD4-DF6D-B799-7259-FEBA97483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9503756-3E1C-826A-AE12-6492A02D6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AC38B06-FB2A-4ACF-C35A-66977EB77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5379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8180A5-1D83-6692-C3B2-0FE5ED306F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509E178-75B0-8A76-7232-0FFA4E4039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F005A20-35D4-2615-3450-B4F8F748F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7297057-C739-130A-EF6C-23A89431F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18B75B6-710B-68B2-C213-F179933F4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8414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5CA1665-EA1C-A954-8B87-9834C3046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BFEE8F3-7A74-F964-DAFB-9EA7BA6608B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2CEC02C-B40E-ABF4-BEA0-99A61F781C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52320E4-9E12-BD4A-E649-B8144B56B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E73443E-DA9F-8E3E-C0F3-3F4B3E042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D92F3F6-EC2E-0681-6A5A-92F5B4C6F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3581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2011A63-5F40-16E8-B244-1B2FFD6980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9BDE7D9-EFA4-C825-3F64-16DE6F3BCF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37B5C73-6003-7C4D-AB2D-12153EACC8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1CE9834-5856-F3CA-71BC-0B6EC3D0367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0BD3021-9AF5-37A2-76F2-DF391549DA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9CA4F50-B033-01D9-A5DC-55910D562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DC13EB38-E7F4-D783-7B3E-8F2A49F0D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A9B7945-E083-E8E1-DEBD-728D9282F7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3870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C0339D0-1FD8-BC65-9AC4-DF565734A8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C79DE8E-650D-6C89-483F-CBFE112C1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EEB57DB8-F703-841E-0ACF-D7523029B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FBDDACE3-571E-CCC5-396D-55F633CAC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1126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BEE7113F-5C82-E08F-1FFE-40AF2815EF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36931D2-45DD-6517-E7A7-75A34936B7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51BFA27F-A619-D1C1-BD8F-7124C6E05F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27280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932AEFA-3FAE-F691-E4DF-B274E7386D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6507F2E-0B78-8DE1-7E91-6E20323C14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420CFA4-1232-E703-3CDB-47C83EC1E3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BAB876D-0B13-896C-788C-804427BDB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03AB58C-0F22-1B09-9DAA-A0A916C2E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0A560E6-4F44-712C-AB2A-585F59F8E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5453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2842232-A5D2-2166-4B48-FD99C39D3B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0A2A4C6B-66A3-6516-6769-81BC03DE09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EA928B9-E66E-4ADF-9D4A-735B1B6CF6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B822CB2-E100-F342-7CA2-29441E2F47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E085B73-9E32-E3EE-736B-3D8CF08EE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A93F9FF-B7E0-EF2F-0666-0DB9E4E59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81965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85F9D36-9853-2D85-5AE5-FA9F38986C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8DA42FB-A330-CF5E-ED2B-049BD138EB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20CFAE-B9F2-A0AA-DE74-1D4DD7FA7D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C33A9-907C-48FB-9AA4-7D9ACCC8F164}" type="datetimeFigureOut">
              <a:rPr lang="it-IT" smtClean="0"/>
              <a:t>20/09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A76FCAC-3D92-3708-998B-5944733BB6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3E063C4-B613-C1E3-BC10-E9E4179504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C56F2F-A7B0-4B5F-9A9B-35EBE00FBED1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5271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2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4.emf"/><Relationship Id="rId5" Type="http://schemas.openxmlformats.org/officeDocument/2006/relationships/image" Target="../media/image11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1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3" Type="http://schemas.openxmlformats.org/officeDocument/2006/relationships/image" Target="../media/image16.emf"/><Relationship Id="rId7" Type="http://schemas.openxmlformats.org/officeDocument/2006/relationships/image" Target="../media/image18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17.emf"/><Relationship Id="rId4" Type="http://schemas.openxmlformats.org/officeDocument/2006/relationships/oleObject" Target="../embeddings/oleObject8.bin"/><Relationship Id="rId9" Type="http://schemas.openxmlformats.org/officeDocument/2006/relationships/image" Target="../media/image1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FA92C544-A8F2-BA2A-1968-C95D89F45E77}"/>
              </a:ext>
            </a:extLst>
          </p:cNvPr>
          <p:cNvGrpSpPr/>
          <p:nvPr/>
        </p:nvGrpSpPr>
        <p:grpSpPr>
          <a:xfrm>
            <a:off x="0" y="-753783"/>
            <a:ext cx="9239375" cy="7050128"/>
            <a:chOff x="0" y="-753783"/>
            <a:chExt cx="9239375" cy="7050128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6342D22A-7395-4437-0EA9-016FCC5EB541}"/>
                </a:ext>
              </a:extLst>
            </p:cNvPr>
            <p:cNvGrpSpPr/>
            <p:nvPr/>
          </p:nvGrpSpPr>
          <p:grpSpPr>
            <a:xfrm>
              <a:off x="0" y="-753783"/>
              <a:ext cx="9239375" cy="7050128"/>
              <a:chOff x="0" y="-753783"/>
              <a:chExt cx="9239375" cy="7050128"/>
            </a:xfrm>
          </p:grpSpPr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901D7C4C-5A43-F4AF-4F90-694B4E32FBF8}"/>
                  </a:ext>
                </a:extLst>
              </p:cNvPr>
              <p:cNvGrpSpPr/>
              <p:nvPr/>
            </p:nvGrpSpPr>
            <p:grpSpPr>
              <a:xfrm>
                <a:off x="424543" y="1381502"/>
                <a:ext cx="2968185" cy="2882492"/>
                <a:chOff x="452528" y="1365970"/>
                <a:chExt cx="2968185" cy="2882492"/>
              </a:xfrm>
            </p:grpSpPr>
            <p:sp>
              <p:nvSpPr>
                <p:cNvPr id="63" name="Textfeld 37">
                  <a:extLst>
                    <a:ext uri="{FF2B5EF4-FFF2-40B4-BE49-F238E27FC236}">
                      <a16:creationId xmlns:a16="http://schemas.microsoft.com/office/drawing/2014/main" id="{2A88BE2F-645D-C1CB-57F5-A2D9EB6543A0}"/>
                    </a:ext>
                  </a:extLst>
                </p:cNvPr>
                <p:cNvSpPr txBox="1"/>
                <p:nvPr/>
              </p:nvSpPr>
              <p:spPr>
                <a:xfrm rot="16200000">
                  <a:off x="-114444" y="1932942"/>
                  <a:ext cx="13647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SC-A</a:t>
                  </a:r>
                </a:p>
              </p:txBody>
            </p:sp>
            <p:sp>
              <p:nvSpPr>
                <p:cNvPr id="64" name="Textfeld 38">
                  <a:extLst>
                    <a:ext uri="{FF2B5EF4-FFF2-40B4-BE49-F238E27FC236}">
                      <a16:creationId xmlns:a16="http://schemas.microsoft.com/office/drawing/2014/main" id="{EEA7259D-DEE3-A09F-98AA-86FD0A37DDB2}"/>
                    </a:ext>
                  </a:extLst>
                </p:cNvPr>
                <p:cNvSpPr txBox="1"/>
                <p:nvPr/>
              </p:nvSpPr>
              <p:spPr>
                <a:xfrm>
                  <a:off x="2055937" y="4017630"/>
                  <a:ext cx="136477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SC-A</a:t>
                  </a:r>
                </a:p>
              </p:txBody>
            </p:sp>
          </p:grp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1D30A3C8-F5AA-3B6C-7A9E-4A7A5D4AF0D9}"/>
                  </a:ext>
                </a:extLst>
              </p:cNvPr>
              <p:cNvGrpSpPr/>
              <p:nvPr/>
            </p:nvGrpSpPr>
            <p:grpSpPr>
              <a:xfrm>
                <a:off x="0" y="-753783"/>
                <a:ext cx="9239375" cy="7050128"/>
                <a:chOff x="0" y="-753783"/>
                <a:chExt cx="9239375" cy="7050128"/>
              </a:xfrm>
            </p:grpSpPr>
            <p:grpSp>
              <p:nvGrpSpPr>
                <p:cNvPr id="4" name="Group 3">
                  <a:extLst>
                    <a:ext uri="{FF2B5EF4-FFF2-40B4-BE49-F238E27FC236}">
                      <a16:creationId xmlns:a16="http://schemas.microsoft.com/office/drawing/2014/main" id="{AAA5AEC9-9307-5B8C-10A3-4766D861AABD}"/>
                    </a:ext>
                  </a:extLst>
                </p:cNvPr>
                <p:cNvGrpSpPr/>
                <p:nvPr/>
              </p:nvGrpSpPr>
              <p:grpSpPr>
                <a:xfrm>
                  <a:off x="0" y="-753783"/>
                  <a:ext cx="9239375" cy="7050128"/>
                  <a:chOff x="0" y="-753783"/>
                  <a:chExt cx="9239375" cy="7050128"/>
                </a:xfrm>
              </p:grpSpPr>
              <p:grpSp>
                <p:nvGrpSpPr>
                  <p:cNvPr id="57" name="Group 56">
                    <a:extLst>
                      <a:ext uri="{FF2B5EF4-FFF2-40B4-BE49-F238E27FC236}">
                        <a16:creationId xmlns:a16="http://schemas.microsoft.com/office/drawing/2014/main" id="{DBD31A8E-8F2F-4276-72D1-EDC5004C92E3}"/>
                      </a:ext>
                    </a:extLst>
                  </p:cNvPr>
                  <p:cNvGrpSpPr/>
                  <p:nvPr/>
                </p:nvGrpSpPr>
                <p:grpSpPr>
                  <a:xfrm>
                    <a:off x="420857" y="-753783"/>
                    <a:ext cx="8762004" cy="2925265"/>
                    <a:chOff x="135107" y="-658533"/>
                    <a:chExt cx="8762004" cy="2925265"/>
                  </a:xfrm>
                </p:grpSpPr>
                <p:grpSp>
                  <p:nvGrpSpPr>
                    <p:cNvPr id="56" name="Group 55">
                      <a:extLst>
                        <a:ext uri="{FF2B5EF4-FFF2-40B4-BE49-F238E27FC236}">
                          <a16:creationId xmlns:a16="http://schemas.microsoft.com/office/drawing/2014/main" id="{C51B8311-C828-1E9A-FE21-F1B8D4F6566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35107" y="-658533"/>
                      <a:ext cx="8762004" cy="2925265"/>
                      <a:chOff x="135107" y="-658533"/>
                      <a:chExt cx="8762004" cy="2925265"/>
                    </a:xfrm>
                  </p:grpSpPr>
                  <p:grpSp>
                    <p:nvGrpSpPr>
                      <p:cNvPr id="9" name="Group 8">
                        <a:extLst>
                          <a:ext uri="{FF2B5EF4-FFF2-40B4-BE49-F238E27FC236}">
                            <a16:creationId xmlns:a16="http://schemas.microsoft.com/office/drawing/2014/main" id="{220B0BA9-8EC2-9253-A917-562FA66413CF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586947" y="171658"/>
                        <a:ext cx="2070112" cy="2039818"/>
                        <a:chOff x="2487344" y="729277"/>
                        <a:chExt cx="1824605" cy="1813810"/>
                      </a:xfrm>
                    </p:grpSpPr>
                    <p:pic>
                      <p:nvPicPr>
                        <p:cNvPr id="6" name="Grafik 24">
                          <a:extLst>
                            <a:ext uri="{FF2B5EF4-FFF2-40B4-BE49-F238E27FC236}">
                              <a16:creationId xmlns:a16="http://schemas.microsoft.com/office/drawing/2014/main" id="{76D52A60-EE69-8A6E-CB0A-96D306DE9E25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2"/>
                        <a:srcRect l="10695" t="2641" b="5483"/>
                        <a:stretch/>
                      </p:blipFill>
                      <p:spPr>
                        <a:xfrm>
                          <a:off x="2680658" y="772175"/>
                          <a:ext cx="1569805" cy="1653750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7" name="Textfeld 44">
                          <a:extLst>
                            <a:ext uri="{FF2B5EF4-FFF2-40B4-BE49-F238E27FC236}">
                              <a16:creationId xmlns:a16="http://schemas.microsoft.com/office/drawing/2014/main" id="{2B72A885-8B69-E65A-7539-D4F7F7AAA8A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1889936" y="1326685"/>
                          <a:ext cx="1425647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D3 APC-Vio770</a:t>
                          </a:r>
                        </a:p>
                      </p:txBody>
                    </p:sp>
                    <p:sp>
                      <p:nvSpPr>
                        <p:cNvPr id="8" name="Textfeld 45">
                          <a:extLst>
                            <a:ext uri="{FF2B5EF4-FFF2-40B4-BE49-F238E27FC236}">
                              <a16:creationId xmlns:a16="http://schemas.microsoft.com/office/drawing/2014/main" id="{F7F5E0CD-1ACC-0227-7A74-0CB7EFC2AE5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723210" y="2312255"/>
                          <a:ext cx="588739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SC-A</a:t>
                          </a:r>
                        </a:p>
                      </p:txBody>
                    </p:sp>
                    <p:sp>
                      <p:nvSpPr>
                        <p:cNvPr id="3" name="Textfeld 25">
                          <a:extLst>
                            <a:ext uri="{FF2B5EF4-FFF2-40B4-BE49-F238E27FC236}">
                              <a16:creationId xmlns:a16="http://schemas.microsoft.com/office/drawing/2014/main" id="{BED66F06-C6CD-9867-B6AB-0F67857BA1A6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640297" y="854644"/>
                          <a:ext cx="533401" cy="50783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T cells</a:t>
                          </a:r>
                        </a:p>
                        <a:p>
                          <a:pPr algn="ct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1.3%</a:t>
                          </a:r>
                        </a:p>
                        <a:p>
                          <a:pPr algn="ctr"/>
                          <a:endParaRPr lang="en-AU" sz="9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23" name="Group 22">
                        <a:extLst>
                          <a:ext uri="{FF2B5EF4-FFF2-40B4-BE49-F238E27FC236}">
                            <a16:creationId xmlns:a16="http://schemas.microsoft.com/office/drawing/2014/main" id="{C018C7E6-6432-6AE9-51CD-635A9CA72B5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35107" y="-658533"/>
                        <a:ext cx="2968185" cy="2882492"/>
                        <a:chOff x="344657" y="-629958"/>
                        <a:chExt cx="2968185" cy="2882492"/>
                      </a:xfrm>
                    </p:grpSpPr>
                    <p:pic>
                      <p:nvPicPr>
                        <p:cNvPr id="22" name="Picture 21">
                          <a:extLst>
                            <a:ext uri="{FF2B5EF4-FFF2-40B4-BE49-F238E27FC236}">
                              <a16:creationId xmlns:a16="http://schemas.microsoft.com/office/drawing/2014/main" id="{B1FB4A57-0F58-9713-1561-EDA4CDACA543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3"/>
                        <a:srcRect l="7485" b="5357"/>
                        <a:stretch/>
                      </p:blipFill>
                      <p:spPr>
                        <a:xfrm>
                          <a:off x="498270" y="212716"/>
                          <a:ext cx="1889602" cy="1862143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16" name="Textfeld 37">
                          <a:extLst>
                            <a:ext uri="{FF2B5EF4-FFF2-40B4-BE49-F238E27FC236}">
                              <a16:creationId xmlns:a16="http://schemas.microsoft.com/office/drawing/2014/main" id="{C472B234-5B20-CDCA-ECBC-B29D6675F09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-222315" y="-62986"/>
                          <a:ext cx="1364776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SC-A</a:t>
                          </a:r>
                        </a:p>
                      </p:txBody>
                    </p:sp>
                    <p:sp>
                      <p:nvSpPr>
                        <p:cNvPr id="17" name="Textfeld 9">
                          <a:extLst>
                            <a:ext uri="{FF2B5EF4-FFF2-40B4-BE49-F238E27FC236}">
                              <a16:creationId xmlns:a16="http://schemas.microsoft.com/office/drawing/2014/main" id="{DEDA2AE7-BDE4-A7B7-E41F-6FF24A06301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69299" y="360513"/>
                          <a:ext cx="768950" cy="50783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erebellum cells</a:t>
                          </a:r>
                        </a:p>
                        <a:p>
                          <a:pPr algn="ct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86.2%</a:t>
                          </a:r>
                        </a:p>
                      </p:txBody>
                    </p:sp>
                    <p:sp>
                      <p:nvSpPr>
                        <p:cNvPr id="18" name="Textfeld 38">
                          <a:extLst>
                            <a:ext uri="{FF2B5EF4-FFF2-40B4-BE49-F238E27FC236}">
                              <a16:creationId xmlns:a16="http://schemas.microsoft.com/office/drawing/2014/main" id="{1A77A856-4F22-C1B2-E433-066BE665B98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948066" y="2021702"/>
                          <a:ext cx="1364776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SC-A</a:t>
                          </a:r>
                        </a:p>
                      </p:txBody>
                    </p:sp>
                  </p:grpSp>
                  <p:grpSp>
                    <p:nvGrpSpPr>
                      <p:cNvPr id="32" name="Group 31">
                        <a:extLst>
                          <a:ext uri="{FF2B5EF4-FFF2-40B4-BE49-F238E27FC236}">
                            <a16:creationId xmlns:a16="http://schemas.microsoft.com/office/drawing/2014/main" id="{A0C9B4B5-EED7-63BF-6AE1-279D865E5DA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253359" y="-578210"/>
                        <a:ext cx="2946466" cy="2844942"/>
                        <a:chOff x="4513970" y="157381"/>
                        <a:chExt cx="3057258" cy="3002393"/>
                      </a:xfrm>
                    </p:grpSpPr>
                    <p:pic>
                      <p:nvPicPr>
                        <p:cNvPr id="28" name="Picture 27">
                          <a:extLst>
                            <a:ext uri="{FF2B5EF4-FFF2-40B4-BE49-F238E27FC236}">
                              <a16:creationId xmlns:a16="http://schemas.microsoft.com/office/drawing/2014/main" id="{65883FCE-AF60-F245-A02F-F56589F003D1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4"/>
                        <a:srcRect l="7194" b="6890"/>
                        <a:stretch/>
                      </p:blipFill>
                      <p:spPr>
                        <a:xfrm>
                          <a:off x="4659175" y="970533"/>
                          <a:ext cx="2016568" cy="1948928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29" name="Textfeld 37">
                          <a:extLst>
                            <a:ext uri="{FF2B5EF4-FFF2-40B4-BE49-F238E27FC236}">
                              <a16:creationId xmlns:a16="http://schemas.microsoft.com/office/drawing/2014/main" id="{F7BDA6E2-B6FD-F489-A18D-FE3E7B4370B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3946998" y="724353"/>
                          <a:ext cx="1364776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SC-H</a:t>
                          </a:r>
                        </a:p>
                      </p:txBody>
                    </p:sp>
                    <p:sp>
                      <p:nvSpPr>
                        <p:cNvPr id="30" name="Textfeld 9">
                          <a:extLst>
                            <a:ext uri="{FF2B5EF4-FFF2-40B4-BE49-F238E27FC236}">
                              <a16:creationId xmlns:a16="http://schemas.microsoft.com/office/drawing/2014/main" id="{03B4AF8C-D759-98B1-011C-4B58A0972A8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834557" y="2065228"/>
                          <a:ext cx="768950" cy="36933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ingle cells</a:t>
                          </a:r>
                        </a:p>
                        <a:p>
                          <a:pPr algn="ct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81.3%</a:t>
                          </a:r>
                        </a:p>
                      </p:txBody>
                    </p:sp>
                    <p:sp>
                      <p:nvSpPr>
                        <p:cNvPr id="31" name="Textfeld 38">
                          <a:extLst>
                            <a:ext uri="{FF2B5EF4-FFF2-40B4-BE49-F238E27FC236}">
                              <a16:creationId xmlns:a16="http://schemas.microsoft.com/office/drawing/2014/main" id="{4AC7BF5C-3B78-4B35-BA16-70B0CCD2264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206452" y="2928942"/>
                          <a:ext cx="1364776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SC-A</a:t>
                          </a:r>
                        </a:p>
                      </p:txBody>
                    </p:sp>
                  </p:grpSp>
                  <p:cxnSp>
                    <p:nvCxnSpPr>
                      <p:cNvPr id="33" name="Straight Arrow Connector 32">
                        <a:extLst>
                          <a:ext uri="{FF2B5EF4-FFF2-40B4-BE49-F238E27FC236}">
                            <a16:creationId xmlns:a16="http://schemas.microsoft.com/office/drawing/2014/main" id="{2AC72C5C-6ED2-DA45-0507-81BF3A5D260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3556366" y="1120081"/>
                        <a:ext cx="975788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53" name="Group 52">
                        <a:extLst>
                          <a:ext uri="{FF2B5EF4-FFF2-40B4-BE49-F238E27FC236}">
                            <a16:creationId xmlns:a16="http://schemas.microsoft.com/office/drawing/2014/main" id="{1A413095-E6E5-4639-E02F-EFBD2575AAE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782666" y="219900"/>
                        <a:ext cx="2114445" cy="2017207"/>
                        <a:chOff x="4770997" y="2100938"/>
                        <a:chExt cx="1899929" cy="1922490"/>
                      </a:xfrm>
                    </p:grpSpPr>
                    <p:pic>
                      <p:nvPicPr>
                        <p:cNvPr id="49" name="Picture 48">
                          <a:extLst>
                            <a:ext uri="{FF2B5EF4-FFF2-40B4-BE49-F238E27FC236}">
                              <a16:creationId xmlns:a16="http://schemas.microsoft.com/office/drawing/2014/main" id="{0D809E73-E6B4-0B15-C468-7585FD354A25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5"/>
                        <a:srcRect l="9687" t="2144" b="7461"/>
                        <a:stretch/>
                      </p:blipFill>
                      <p:spPr>
                        <a:xfrm>
                          <a:off x="4962998" y="2100938"/>
                          <a:ext cx="1638986" cy="1740100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50" name="Textfeld 44">
                          <a:extLst>
                            <a:ext uri="{FF2B5EF4-FFF2-40B4-BE49-F238E27FC236}">
                              <a16:creationId xmlns:a16="http://schemas.microsoft.com/office/drawing/2014/main" id="{7CC3D047-BC4B-BEFF-B57C-5433166667C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 rot="16200000">
                          <a:off x="4136369" y="2749536"/>
                          <a:ext cx="1500087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D14 PE-Vio770</a:t>
                          </a:r>
                        </a:p>
                      </p:txBody>
                    </p:sp>
                    <p:sp>
                      <p:nvSpPr>
                        <p:cNvPr id="51" name="Textfeld 45">
                          <a:extLst>
                            <a:ext uri="{FF2B5EF4-FFF2-40B4-BE49-F238E27FC236}">
                              <a16:creationId xmlns:a16="http://schemas.microsoft.com/office/drawing/2014/main" id="{92190FD7-59CC-9555-5F4E-0BCA1F47EB6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056241" y="3780543"/>
                          <a:ext cx="614685" cy="24288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SC-A</a:t>
                          </a:r>
                        </a:p>
                      </p:txBody>
                    </p:sp>
                    <p:sp>
                      <p:nvSpPr>
                        <p:cNvPr id="52" name="Textfeld 25">
                          <a:extLst>
                            <a:ext uri="{FF2B5EF4-FFF2-40B4-BE49-F238E27FC236}">
                              <a16:creationId xmlns:a16="http://schemas.microsoft.com/office/drawing/2014/main" id="{45E9CE01-A3FB-958E-07B4-791DE1FB610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517927" y="2432908"/>
                          <a:ext cx="896137" cy="50783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D14</a:t>
                          </a:r>
                          <a:r>
                            <a:rPr lang="en-AU" sz="900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+</a:t>
                          </a:r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 cells</a:t>
                          </a:r>
                        </a:p>
                        <a:p>
                          <a:pPr algn="ctr"/>
                          <a:r>
                            <a:rPr lang="en-AU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21.2%</a:t>
                          </a:r>
                        </a:p>
                        <a:p>
                          <a:pPr algn="ctr"/>
                          <a:endParaRPr lang="en-AU" sz="9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</p:grpSp>
                </p:grpSp>
                <p:cxnSp>
                  <p:nvCxnSpPr>
                    <p:cNvPr id="25" name="Straight Arrow Connector 24">
                      <a:extLst>
                        <a:ext uri="{FF2B5EF4-FFF2-40B4-BE49-F238E27FC236}">
                          <a16:creationId xmlns:a16="http://schemas.microsoft.com/office/drawing/2014/main" id="{14444275-B8D9-B85A-4DAC-20E2A3FA431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495425" y="1143788"/>
                      <a:ext cx="920829" cy="437362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58" name="CasellaDiTesto 20">
                    <a:extLst>
                      <a:ext uri="{FF2B5EF4-FFF2-40B4-BE49-F238E27FC236}">
                        <a16:creationId xmlns:a16="http://schemas.microsoft.com/office/drawing/2014/main" id="{828A444B-2CB8-88AF-8F89-BA41B6542261}"/>
                      </a:ext>
                    </a:extLst>
                  </p:cNvPr>
                  <p:cNvSpPr txBox="1"/>
                  <p:nvPr/>
                </p:nvSpPr>
                <p:spPr>
                  <a:xfrm>
                    <a:off x="0" y="-15563"/>
                    <a:ext cx="28632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  <p:sp>
                <p:nvSpPr>
                  <p:cNvPr id="60" name="CasellaDiTesto 20">
                    <a:extLst>
                      <a:ext uri="{FF2B5EF4-FFF2-40B4-BE49-F238E27FC236}">
                        <a16:creationId xmlns:a16="http://schemas.microsoft.com/office/drawing/2014/main" id="{107521EA-245A-68F4-452D-9525E22019EA}"/>
                      </a:ext>
                    </a:extLst>
                  </p:cNvPr>
                  <p:cNvSpPr txBox="1"/>
                  <p:nvPr/>
                </p:nvSpPr>
                <p:spPr>
                  <a:xfrm>
                    <a:off x="0" y="2013293"/>
                    <a:ext cx="28632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it-IT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</a:p>
                </p:txBody>
              </p:sp>
              <p:grpSp>
                <p:nvGrpSpPr>
                  <p:cNvPr id="99" name="Group 98">
                    <a:extLst>
                      <a:ext uri="{FF2B5EF4-FFF2-40B4-BE49-F238E27FC236}">
                        <a16:creationId xmlns:a16="http://schemas.microsoft.com/office/drawing/2014/main" id="{805EB6A0-87DC-9B23-448D-DF81827DDF4B}"/>
                      </a:ext>
                    </a:extLst>
                  </p:cNvPr>
                  <p:cNvGrpSpPr/>
                  <p:nvPr/>
                </p:nvGrpSpPr>
                <p:grpSpPr>
                  <a:xfrm>
                    <a:off x="633322" y="2144936"/>
                    <a:ext cx="1985199" cy="1784602"/>
                    <a:chOff x="648420" y="2067557"/>
                    <a:chExt cx="1985199" cy="1784602"/>
                  </a:xfrm>
                </p:grpSpPr>
                <p:pic>
                  <p:nvPicPr>
                    <p:cNvPr id="98" name="Picture 97">
                      <a:extLst>
                        <a:ext uri="{FF2B5EF4-FFF2-40B4-BE49-F238E27FC236}">
                          <a16:creationId xmlns:a16="http://schemas.microsoft.com/office/drawing/2014/main" id="{D2ABDC73-2199-91B4-AA41-009557A4D33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6"/>
                    <a:srcRect l="11059" b="5836"/>
                    <a:stretch/>
                  </p:blipFill>
                  <p:spPr>
                    <a:xfrm>
                      <a:off x="648420" y="2067557"/>
                      <a:ext cx="1808284" cy="178460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66" name="Textfeld 9">
                      <a:extLst>
                        <a:ext uri="{FF2B5EF4-FFF2-40B4-BE49-F238E27FC236}">
                          <a16:creationId xmlns:a16="http://schemas.microsoft.com/office/drawing/2014/main" id="{7BEE0E76-B7C5-4E1C-934B-65BBCA42681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60846" y="3332370"/>
                      <a:ext cx="972773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ocytes</a:t>
                      </a:r>
                    </a:p>
                    <a:p>
                      <a:pPr algn="ct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4%</a:t>
                      </a:r>
                    </a:p>
                  </p:txBody>
                </p:sp>
              </p:grpSp>
              <p:grpSp>
                <p:nvGrpSpPr>
                  <p:cNvPr id="73" name="Group 72">
                    <a:extLst>
                      <a:ext uri="{FF2B5EF4-FFF2-40B4-BE49-F238E27FC236}">
                        <a16:creationId xmlns:a16="http://schemas.microsoft.com/office/drawing/2014/main" id="{D04CF126-B687-7272-1258-4A096AD637F9}"/>
                      </a:ext>
                    </a:extLst>
                  </p:cNvPr>
                  <p:cNvGrpSpPr/>
                  <p:nvPr/>
                </p:nvGrpSpPr>
                <p:grpSpPr>
                  <a:xfrm>
                    <a:off x="2539108" y="2221992"/>
                    <a:ext cx="2106129" cy="2042002"/>
                    <a:chOff x="2662311" y="2221992"/>
                    <a:chExt cx="2106129" cy="2042002"/>
                  </a:xfrm>
                </p:grpSpPr>
                <p:pic>
                  <p:nvPicPr>
                    <p:cNvPr id="69" name="Grafik 52">
                      <a:extLst>
                        <a:ext uri="{FF2B5EF4-FFF2-40B4-BE49-F238E27FC236}">
                          <a16:creationId xmlns:a16="http://schemas.microsoft.com/office/drawing/2014/main" id="{959059E6-19E7-14AD-761C-205D8425631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7"/>
                    <a:srcRect l="8068" t="569" b="6052"/>
                    <a:stretch/>
                  </p:blipFill>
                  <p:spPr>
                    <a:xfrm>
                      <a:off x="2861447" y="2254755"/>
                      <a:ext cx="1884297" cy="181464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71" name="Textfeld 62">
                      <a:extLst>
                        <a:ext uri="{FF2B5EF4-FFF2-40B4-BE49-F238E27FC236}">
                          <a16:creationId xmlns:a16="http://schemas.microsoft.com/office/drawing/2014/main" id="{EAB6DBB7-B7D9-1E67-DF4D-98D645E3C43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231596" y="4033162"/>
                      <a:ext cx="536844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C-A</a:t>
                      </a:r>
                    </a:p>
                  </p:txBody>
                </p:sp>
                <p:sp>
                  <p:nvSpPr>
                    <p:cNvPr id="70" name="Textfeld 61">
                      <a:extLst>
                        <a:ext uri="{FF2B5EF4-FFF2-40B4-BE49-F238E27FC236}">
                          <a16:creationId xmlns:a16="http://schemas.microsoft.com/office/drawing/2014/main" id="{632D2329-9D74-8931-97C1-408760400D99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2487104" y="2397199"/>
                      <a:ext cx="581246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C-H</a:t>
                      </a:r>
                    </a:p>
                  </p:txBody>
                </p:sp>
              </p:grpSp>
              <p:cxnSp>
                <p:nvCxnSpPr>
                  <p:cNvPr id="67" name="Straight Arrow Connector 66">
                    <a:extLst>
                      <a:ext uri="{FF2B5EF4-FFF2-40B4-BE49-F238E27FC236}">
                        <a16:creationId xmlns:a16="http://schemas.microsoft.com/office/drawing/2014/main" id="{DF3D5771-EFFD-74F8-D8FE-15407FD67BD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799396" y="3267075"/>
                    <a:ext cx="1589646" cy="43808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" name="Straight Arrow Connector 74">
                    <a:extLst>
                      <a:ext uri="{FF2B5EF4-FFF2-40B4-BE49-F238E27FC236}">
                        <a16:creationId xmlns:a16="http://schemas.microsoft.com/office/drawing/2014/main" id="{D39B928C-109A-ED00-975F-70B7498BD85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650797" y="3303287"/>
                    <a:ext cx="1221899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83" name="Group 82">
                    <a:extLst>
                      <a:ext uri="{FF2B5EF4-FFF2-40B4-BE49-F238E27FC236}">
                        <a16:creationId xmlns:a16="http://schemas.microsoft.com/office/drawing/2014/main" id="{445D0A90-67E4-D6C7-ABA8-7BFBC16BD075}"/>
                      </a:ext>
                    </a:extLst>
                  </p:cNvPr>
                  <p:cNvGrpSpPr/>
                  <p:nvPr/>
                </p:nvGrpSpPr>
                <p:grpSpPr>
                  <a:xfrm>
                    <a:off x="4945988" y="2254755"/>
                    <a:ext cx="1982448" cy="2023620"/>
                    <a:chOff x="4938358" y="2248297"/>
                    <a:chExt cx="1982448" cy="2023620"/>
                  </a:xfrm>
                </p:grpSpPr>
                <p:pic>
                  <p:nvPicPr>
                    <p:cNvPr id="78" name="Picture 77">
                      <a:extLst>
                        <a:ext uri="{FF2B5EF4-FFF2-40B4-BE49-F238E27FC236}">
                          <a16:creationId xmlns:a16="http://schemas.microsoft.com/office/drawing/2014/main" id="{D8205F3D-E721-CC84-FB58-7B3B0EB1162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8"/>
                    <a:srcRect l="6871" b="6532"/>
                    <a:stretch/>
                  </p:blipFill>
                  <p:spPr>
                    <a:xfrm>
                      <a:off x="5075316" y="2249821"/>
                      <a:ext cx="1776302" cy="1799877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80" name="Textfeld 44">
                      <a:extLst>
                        <a:ext uri="{FF2B5EF4-FFF2-40B4-BE49-F238E27FC236}">
                          <a16:creationId xmlns:a16="http://schemas.microsoft.com/office/drawing/2014/main" id="{350A7F12-752D-564F-09A2-03F5F0BA2E6D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4267660" y="2918995"/>
                      <a:ext cx="1603288" cy="26189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 APC-Vio770</a:t>
                      </a:r>
                    </a:p>
                  </p:txBody>
                </p:sp>
                <p:sp>
                  <p:nvSpPr>
                    <p:cNvPr id="81" name="Textfeld 45">
                      <a:extLst>
                        <a:ext uri="{FF2B5EF4-FFF2-40B4-BE49-F238E27FC236}">
                          <a16:creationId xmlns:a16="http://schemas.microsoft.com/office/drawing/2014/main" id="{92DF92F2-EF78-5391-6450-9B292E147AB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52850" y="4012322"/>
                      <a:ext cx="667956" cy="25959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C-A</a:t>
                      </a:r>
                    </a:p>
                  </p:txBody>
                </p:sp>
                <p:sp>
                  <p:nvSpPr>
                    <p:cNvPr id="82" name="Textfeld 25">
                      <a:extLst>
                        <a:ext uri="{FF2B5EF4-FFF2-40B4-BE49-F238E27FC236}">
                          <a16:creationId xmlns:a16="http://schemas.microsoft.com/office/drawing/2014/main" id="{4CE3C417-D05B-9C52-89F9-0B8168BC6E7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245875" y="2387220"/>
                      <a:ext cx="605172" cy="5078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 cells</a:t>
                      </a:r>
                    </a:p>
                    <a:p>
                      <a:pPr algn="ct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5%</a:t>
                      </a:r>
                    </a:p>
                    <a:p>
                      <a:pPr algn="ctr"/>
                      <a:endParaRPr lang="en-AU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94" name="Group 93">
                    <a:extLst>
                      <a:ext uri="{FF2B5EF4-FFF2-40B4-BE49-F238E27FC236}">
                        <a16:creationId xmlns:a16="http://schemas.microsoft.com/office/drawing/2014/main" id="{9695EE5A-3DAC-AC34-C59B-CA80879DF2E1}"/>
                      </a:ext>
                    </a:extLst>
                  </p:cNvPr>
                  <p:cNvGrpSpPr/>
                  <p:nvPr/>
                </p:nvGrpSpPr>
                <p:grpSpPr>
                  <a:xfrm>
                    <a:off x="4918322" y="4327970"/>
                    <a:ext cx="1954728" cy="1968375"/>
                    <a:chOff x="5047116" y="4278375"/>
                    <a:chExt cx="1954728" cy="1968375"/>
                  </a:xfrm>
                </p:grpSpPr>
                <p:grpSp>
                  <p:nvGrpSpPr>
                    <p:cNvPr id="91" name="Group 90">
                      <a:extLst>
                        <a:ext uri="{FF2B5EF4-FFF2-40B4-BE49-F238E27FC236}">
                          <a16:creationId xmlns:a16="http://schemas.microsoft.com/office/drawing/2014/main" id="{A47ACD81-48C5-B381-59CC-1CC2AB84AF4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047116" y="4278375"/>
                      <a:ext cx="1954728" cy="1968375"/>
                      <a:chOff x="4903949" y="4327970"/>
                      <a:chExt cx="1954728" cy="1968375"/>
                    </a:xfrm>
                  </p:grpSpPr>
                  <p:pic>
                    <p:nvPicPr>
                      <p:cNvPr id="87" name="Picture 86">
                        <a:extLst>
                          <a:ext uri="{FF2B5EF4-FFF2-40B4-BE49-F238E27FC236}">
                            <a16:creationId xmlns:a16="http://schemas.microsoft.com/office/drawing/2014/main" id="{2ACAFBF3-563E-2A30-2034-8812E0DFBA4F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9"/>
                      <a:srcRect l="10674" b="5522"/>
                      <a:stretch/>
                    </p:blipFill>
                    <p:spPr>
                      <a:xfrm>
                        <a:off x="5134378" y="4327970"/>
                        <a:ext cx="1695724" cy="1765506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89" name="Textfeld 44">
                        <a:extLst>
                          <a:ext uri="{FF2B5EF4-FFF2-40B4-BE49-F238E27FC236}">
                            <a16:creationId xmlns:a16="http://schemas.microsoft.com/office/drawing/2014/main" id="{4D8FA35B-FA4E-7FD1-7FDC-1015DB6BC7C7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4217721" y="5014198"/>
                        <a:ext cx="1603288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AU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D4 Viogreen</a:t>
                        </a:r>
                      </a:p>
                    </p:txBody>
                  </p:sp>
                  <p:sp>
                    <p:nvSpPr>
                      <p:cNvPr id="90" name="Textfeld 45">
                        <a:extLst>
                          <a:ext uri="{FF2B5EF4-FFF2-40B4-BE49-F238E27FC236}">
                            <a16:creationId xmlns:a16="http://schemas.microsoft.com/office/drawing/2014/main" id="{E286D98C-055C-B8B8-8A0D-829FF92FA82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014952" y="6065513"/>
                        <a:ext cx="843725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r"/>
                        <a:r>
                          <a:rPr lang="en-AU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D8 Percp</a:t>
                        </a:r>
                      </a:p>
                    </p:txBody>
                  </p:sp>
                </p:grpSp>
                <p:sp>
                  <p:nvSpPr>
                    <p:cNvPr id="92" name="Textfeld 25">
                      <a:extLst>
                        <a:ext uri="{FF2B5EF4-FFF2-40B4-BE49-F238E27FC236}">
                          <a16:creationId xmlns:a16="http://schemas.microsoft.com/office/drawing/2014/main" id="{7B77CD48-ED9D-3269-95F6-02CC417DC17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67464" y="4327970"/>
                      <a:ext cx="605172" cy="5078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  <a:r>
                        <a:rPr lang="en-AU" sz="9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2%</a:t>
                      </a:r>
                    </a:p>
                    <a:p>
                      <a:pPr algn="ctr"/>
                      <a:endParaRPr lang="en-AU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93" name="Textfeld 25">
                      <a:extLst>
                        <a:ext uri="{FF2B5EF4-FFF2-40B4-BE49-F238E27FC236}">
                          <a16:creationId xmlns:a16="http://schemas.microsoft.com/office/drawing/2014/main" id="{E5AE3B43-E7B3-6B0F-916D-BDCE6E10B16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793414" y="5498922"/>
                      <a:ext cx="605172" cy="5078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  <a:r>
                        <a:rPr lang="en-AU" sz="900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  <a:p>
                      <a:pPr algn="ct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6%</a:t>
                      </a:r>
                    </a:p>
                    <a:p>
                      <a:pPr algn="ctr"/>
                      <a:endParaRPr lang="en-AU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cxnSp>
                <p:nvCxnSpPr>
                  <p:cNvPr id="95" name="Straight Arrow Connector 94">
                    <a:extLst>
                      <a:ext uri="{FF2B5EF4-FFF2-40B4-BE49-F238E27FC236}">
                        <a16:creationId xmlns:a16="http://schemas.microsoft.com/office/drawing/2014/main" id="{E61C007E-FAC9-B07F-950C-7605F7D9ED6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872420" y="3429000"/>
                    <a:ext cx="0" cy="849375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05" name="Group 104">
                    <a:extLst>
                      <a:ext uri="{FF2B5EF4-FFF2-40B4-BE49-F238E27FC236}">
                        <a16:creationId xmlns:a16="http://schemas.microsoft.com/office/drawing/2014/main" id="{CF583A35-B2C6-9D06-B9A6-70C68235B980}"/>
                      </a:ext>
                    </a:extLst>
                  </p:cNvPr>
                  <p:cNvGrpSpPr/>
                  <p:nvPr/>
                </p:nvGrpSpPr>
                <p:grpSpPr>
                  <a:xfrm>
                    <a:off x="7137961" y="2221990"/>
                    <a:ext cx="2101414" cy="2002549"/>
                    <a:chOff x="7137961" y="2221990"/>
                    <a:chExt cx="2101414" cy="2002549"/>
                  </a:xfrm>
                </p:grpSpPr>
                <p:pic>
                  <p:nvPicPr>
                    <p:cNvPr id="102" name="Picture 101">
                      <a:extLst>
                        <a:ext uri="{FF2B5EF4-FFF2-40B4-BE49-F238E27FC236}">
                          <a16:creationId xmlns:a16="http://schemas.microsoft.com/office/drawing/2014/main" id="{9090BD28-0EFD-572D-7874-63E666BABF4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10"/>
                    <a:srcRect l="8469" b="6655"/>
                    <a:stretch/>
                  </p:blipFill>
                  <p:spPr>
                    <a:xfrm>
                      <a:off x="7280782" y="2225025"/>
                      <a:ext cx="1824041" cy="183113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03" name="Textfeld 44">
                      <a:extLst>
                        <a:ext uri="{FF2B5EF4-FFF2-40B4-BE49-F238E27FC236}">
                          <a16:creationId xmlns:a16="http://schemas.microsoft.com/office/drawing/2014/main" id="{5A65E6F5-4A7C-41E3-F252-907863A4645A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6466380" y="2893571"/>
                      <a:ext cx="1573993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4 PEcy7</a:t>
                      </a:r>
                    </a:p>
                  </p:txBody>
                </p:sp>
                <p:sp>
                  <p:nvSpPr>
                    <p:cNvPr id="104" name="Textfeld 45">
                      <a:extLst>
                        <a:ext uri="{FF2B5EF4-FFF2-40B4-BE49-F238E27FC236}">
                          <a16:creationId xmlns:a16="http://schemas.microsoft.com/office/drawing/2014/main" id="{500DB34A-A108-4EC3-C5A1-03C0478D73D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555288" y="3969688"/>
                      <a:ext cx="684087" cy="25485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AU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C-A</a:t>
                      </a:r>
                    </a:p>
                  </p:txBody>
                </p:sp>
              </p:grpSp>
            </p:grpSp>
            <p:sp>
              <p:nvSpPr>
                <p:cNvPr id="72" name="Textfeld 69">
                  <a:extLst>
                    <a:ext uri="{FF2B5EF4-FFF2-40B4-BE49-F238E27FC236}">
                      <a16:creationId xmlns:a16="http://schemas.microsoft.com/office/drawing/2014/main" id="{E0F0E454-8339-62FE-D99F-C09AAB0DDC62}"/>
                    </a:ext>
                  </a:extLst>
                </p:cNvPr>
                <p:cNvSpPr txBox="1"/>
                <p:nvPr/>
              </p:nvSpPr>
              <p:spPr>
                <a:xfrm>
                  <a:off x="3439536" y="3491357"/>
                  <a:ext cx="805160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ingle cells</a:t>
                  </a:r>
                </a:p>
                <a:p>
                  <a:pPr algn="ctr"/>
                  <a:r>
                    <a:rPr lang="en-AU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3.8%</a:t>
                  </a:r>
                </a:p>
              </p:txBody>
            </p:sp>
          </p:grpSp>
        </p:grpSp>
        <p:sp>
          <p:nvSpPr>
            <p:cNvPr id="106" name="Textfeld 25">
              <a:extLst>
                <a:ext uri="{FF2B5EF4-FFF2-40B4-BE49-F238E27FC236}">
                  <a16:creationId xmlns:a16="http://schemas.microsoft.com/office/drawing/2014/main" id="{32812FA1-2D63-1AB1-D31D-71B07EEDEB01}"/>
                </a:ext>
              </a:extLst>
            </p:cNvPr>
            <p:cNvSpPr txBox="1"/>
            <p:nvPr/>
          </p:nvSpPr>
          <p:spPr>
            <a:xfrm>
              <a:off x="8242058" y="2398212"/>
              <a:ext cx="997317" cy="507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900" dirty="0">
                  <a:latin typeface="Arial" panose="020B0604020202020204" pitchFamily="34" charset="0"/>
                  <a:cs typeface="Arial" panose="020B0604020202020204" pitchFamily="34" charset="0"/>
                </a:rPr>
                <a:t>CD14</a:t>
              </a:r>
              <a:r>
                <a:rPr lang="en-AU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AU" sz="900" dirty="0">
                  <a:latin typeface="Arial" panose="020B0604020202020204" pitchFamily="34" charset="0"/>
                  <a:cs typeface="Arial" panose="020B0604020202020204" pitchFamily="34" charset="0"/>
                </a:rPr>
                <a:t> cells</a:t>
              </a:r>
            </a:p>
            <a:p>
              <a:pPr algn="ctr"/>
              <a:r>
                <a:rPr lang="en-AU" sz="900" dirty="0">
                  <a:latin typeface="Arial" panose="020B0604020202020204" pitchFamily="34" charset="0"/>
                  <a:cs typeface="Arial" panose="020B0604020202020204" pitchFamily="34" charset="0"/>
                </a:rPr>
                <a:t>9.1%</a:t>
              </a:r>
            </a:p>
            <a:p>
              <a:pPr algn="ctr"/>
              <a:endParaRPr lang="en-AU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4AABE65D-AECF-A733-402D-3E60B6927990}"/>
              </a:ext>
            </a:extLst>
          </p:cNvPr>
          <p:cNvSpPr txBox="1"/>
          <p:nvPr/>
        </p:nvSpPr>
        <p:spPr>
          <a:xfrm>
            <a:off x="10901311" y="6488668"/>
            <a:ext cx="77510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1</a:t>
            </a:r>
            <a:endParaRPr lang="it-IT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40F01EE-3676-29F9-370A-6F5863B79E99}"/>
              </a:ext>
            </a:extLst>
          </p:cNvPr>
          <p:cNvSpPr txBox="1"/>
          <p:nvPr/>
        </p:nvSpPr>
        <p:spPr>
          <a:xfrm>
            <a:off x="7566127" y="4885396"/>
            <a:ext cx="4096482" cy="10820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100" b="1" dirty="0">
                <a:effectLst/>
                <a:latin typeface="Arial" panose="020B0604020202020204" pitchFamily="34" charset="0"/>
                <a:ea typeface="Aptos" panose="020B0004020202020204" pitchFamily="34" charset="0"/>
              </a:rPr>
              <a:t>Figure S1. Gating strategy used for the flow cytometry experiments. 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Gating strategy used to define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T cells and CD14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ells within cerebellar cells, and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T cells (CD8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d CD4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, and monocytes (CD14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cells) within PBMCs. </a:t>
            </a:r>
            <a:endParaRPr lang="it-IT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40194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93968EE-40A4-43F0-DFBF-DC4C71997645}"/>
              </a:ext>
            </a:extLst>
          </p:cNvPr>
          <p:cNvGrpSpPr/>
          <p:nvPr/>
        </p:nvGrpSpPr>
        <p:grpSpPr>
          <a:xfrm>
            <a:off x="-7216" y="128524"/>
            <a:ext cx="18659562" cy="6657759"/>
            <a:chOff x="-7216" y="128524"/>
            <a:chExt cx="18659562" cy="6657759"/>
          </a:xfrm>
        </p:grpSpPr>
        <p:graphicFrame>
          <p:nvGraphicFramePr>
            <p:cNvPr id="3" name="Oggetto 2">
              <a:extLst>
                <a:ext uri="{FF2B5EF4-FFF2-40B4-BE49-F238E27FC236}">
                  <a16:creationId xmlns:a16="http://schemas.microsoft.com/office/drawing/2014/main" id="{AB9193F2-B197-E4CD-567B-5DDE3F9C58F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27078427"/>
                </p:ext>
              </p:extLst>
            </p:nvPr>
          </p:nvGraphicFramePr>
          <p:xfrm>
            <a:off x="-7216" y="296365"/>
            <a:ext cx="1436687" cy="2127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2325305" imgH="3448432" progId="Prism8.Document">
                    <p:embed/>
                  </p:oleObj>
                </mc:Choice>
                <mc:Fallback>
                  <p:oleObj name="Prism 8" r:id="rId2" imgW="2325305" imgH="3448432" progId="Prism8.Document">
                    <p:embed/>
                    <p:pic>
                      <p:nvPicPr>
                        <p:cNvPr id="3" name="Oggetto 2">
                          <a:extLst>
                            <a:ext uri="{FF2B5EF4-FFF2-40B4-BE49-F238E27FC236}">
                              <a16:creationId xmlns:a16="http://schemas.microsoft.com/office/drawing/2014/main" id="{AB9193F2-B197-E4CD-567B-5DDE3F9C58F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-7216" y="296365"/>
                          <a:ext cx="1436687" cy="2127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ggetto 3">
              <a:extLst>
                <a:ext uri="{FF2B5EF4-FFF2-40B4-BE49-F238E27FC236}">
                  <a16:creationId xmlns:a16="http://schemas.microsoft.com/office/drawing/2014/main" id="{77057E49-D426-6C42-BC60-BE497075B08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67929072"/>
                </p:ext>
              </p:extLst>
            </p:nvPr>
          </p:nvGraphicFramePr>
          <p:xfrm>
            <a:off x="4687424" y="295571"/>
            <a:ext cx="1489075" cy="21288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2412054" imgH="3448432" progId="Prism8.Document">
                    <p:embed/>
                  </p:oleObj>
                </mc:Choice>
                <mc:Fallback>
                  <p:oleObj name="Prism 8" r:id="rId4" imgW="2412054" imgH="3448432" progId="Prism8.Document">
                    <p:embed/>
                    <p:pic>
                      <p:nvPicPr>
                        <p:cNvPr id="4" name="Oggetto 3">
                          <a:extLst>
                            <a:ext uri="{FF2B5EF4-FFF2-40B4-BE49-F238E27FC236}">
                              <a16:creationId xmlns:a16="http://schemas.microsoft.com/office/drawing/2014/main" id="{77057E49-D426-6C42-BC60-BE497075B08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687424" y="295571"/>
                          <a:ext cx="1489075" cy="21288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ggetto 4">
              <a:extLst>
                <a:ext uri="{FF2B5EF4-FFF2-40B4-BE49-F238E27FC236}">
                  <a16:creationId xmlns:a16="http://schemas.microsoft.com/office/drawing/2014/main" id="{AA623294-9FE8-F45C-17BE-F921B9E391C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22261283"/>
                </p:ext>
              </p:extLst>
            </p:nvPr>
          </p:nvGraphicFramePr>
          <p:xfrm>
            <a:off x="1518688" y="301830"/>
            <a:ext cx="1435100" cy="2127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2325305" imgH="3448432" progId="Prism8.Document">
                    <p:embed/>
                  </p:oleObj>
                </mc:Choice>
                <mc:Fallback>
                  <p:oleObj name="Prism 8" r:id="rId6" imgW="2325305" imgH="3448432" progId="Prism8.Document">
                    <p:embed/>
                    <p:pic>
                      <p:nvPicPr>
                        <p:cNvPr id="5" name="Oggetto 4">
                          <a:extLst>
                            <a:ext uri="{FF2B5EF4-FFF2-40B4-BE49-F238E27FC236}">
                              <a16:creationId xmlns:a16="http://schemas.microsoft.com/office/drawing/2014/main" id="{AA623294-9FE8-F45C-17BE-F921B9E391C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518688" y="301830"/>
                          <a:ext cx="1435100" cy="2127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Oggetto 5">
              <a:extLst>
                <a:ext uri="{FF2B5EF4-FFF2-40B4-BE49-F238E27FC236}">
                  <a16:creationId xmlns:a16="http://schemas.microsoft.com/office/drawing/2014/main" id="{4106A847-8BBC-C0E6-27C1-4EA5491EBBF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64895751"/>
                </p:ext>
              </p:extLst>
            </p:nvPr>
          </p:nvGraphicFramePr>
          <p:xfrm>
            <a:off x="3098793" y="301830"/>
            <a:ext cx="1490663" cy="2127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2412054" imgH="3448432" progId="Prism8.Document">
                    <p:embed/>
                  </p:oleObj>
                </mc:Choice>
                <mc:Fallback>
                  <p:oleObj name="Prism 8" r:id="rId8" imgW="2412054" imgH="3448432" progId="Prism8.Document">
                    <p:embed/>
                    <p:pic>
                      <p:nvPicPr>
                        <p:cNvPr id="6" name="Oggetto 5">
                          <a:extLst>
                            <a:ext uri="{FF2B5EF4-FFF2-40B4-BE49-F238E27FC236}">
                              <a16:creationId xmlns:a16="http://schemas.microsoft.com/office/drawing/2014/main" id="{4106A847-8BBC-C0E6-27C1-4EA5491EBBF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098793" y="301830"/>
                          <a:ext cx="1490663" cy="2127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ggetto 6">
              <a:extLst>
                <a:ext uri="{FF2B5EF4-FFF2-40B4-BE49-F238E27FC236}">
                  <a16:creationId xmlns:a16="http://schemas.microsoft.com/office/drawing/2014/main" id="{392344A0-1AF8-1B32-A809-BE589D72944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30885551"/>
                </p:ext>
              </p:extLst>
            </p:nvPr>
          </p:nvGraphicFramePr>
          <p:xfrm>
            <a:off x="6346652" y="286840"/>
            <a:ext cx="1417638" cy="21272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2297948" imgH="3446992" progId="Prism8.Document">
                    <p:embed/>
                  </p:oleObj>
                </mc:Choice>
                <mc:Fallback>
                  <p:oleObj name="Prism 8" r:id="rId10" imgW="2297948" imgH="3446992" progId="Prism8.Document">
                    <p:embed/>
                    <p:pic>
                      <p:nvPicPr>
                        <p:cNvPr id="7" name="Oggetto 6">
                          <a:extLst>
                            <a:ext uri="{FF2B5EF4-FFF2-40B4-BE49-F238E27FC236}">
                              <a16:creationId xmlns:a16="http://schemas.microsoft.com/office/drawing/2014/main" id="{392344A0-1AF8-1B32-A809-BE589D72944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6346652" y="286840"/>
                          <a:ext cx="1417638" cy="21272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ggetto 7">
              <a:extLst>
                <a:ext uri="{FF2B5EF4-FFF2-40B4-BE49-F238E27FC236}">
                  <a16:creationId xmlns:a16="http://schemas.microsoft.com/office/drawing/2014/main" id="{723C74F4-D593-854D-A746-CBF422B2E49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500320933"/>
                </p:ext>
              </p:extLst>
            </p:nvPr>
          </p:nvGraphicFramePr>
          <p:xfrm>
            <a:off x="7892146" y="324756"/>
            <a:ext cx="1384271" cy="20663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2" imgW="2291544" imgH="3422904" progId="Prism9.Document">
                    <p:embed/>
                  </p:oleObj>
                </mc:Choice>
                <mc:Fallback>
                  <p:oleObj name="Prism 9" r:id="rId12" imgW="2291544" imgH="3422904" progId="Prism9.Document">
                    <p:embed/>
                    <p:pic>
                      <p:nvPicPr>
                        <p:cNvPr id="8" name="Oggetto 7">
                          <a:extLst>
                            <a:ext uri="{FF2B5EF4-FFF2-40B4-BE49-F238E27FC236}">
                              <a16:creationId xmlns:a16="http://schemas.microsoft.com/office/drawing/2014/main" id="{723C74F4-D593-854D-A746-CBF422B2E49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7892146" y="324756"/>
                          <a:ext cx="1384271" cy="20663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CasellaDiTesto 20">
              <a:extLst>
                <a:ext uri="{FF2B5EF4-FFF2-40B4-BE49-F238E27FC236}">
                  <a16:creationId xmlns:a16="http://schemas.microsoft.com/office/drawing/2014/main" id="{CA4E077D-66EB-4089-BF58-027CAEC21CA9}"/>
                </a:ext>
              </a:extLst>
            </p:cNvPr>
            <p:cNvSpPr txBox="1"/>
            <p:nvPr/>
          </p:nvSpPr>
          <p:spPr>
            <a:xfrm>
              <a:off x="42560" y="128524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" name="CasellaDiTesto 20">
              <a:extLst>
                <a:ext uri="{FF2B5EF4-FFF2-40B4-BE49-F238E27FC236}">
                  <a16:creationId xmlns:a16="http://schemas.microsoft.com/office/drawing/2014/main" id="{C02E07F2-20E1-24CB-2A38-9D71C1276882}"/>
                </a:ext>
              </a:extLst>
            </p:cNvPr>
            <p:cNvSpPr txBox="1"/>
            <p:nvPr/>
          </p:nvSpPr>
          <p:spPr>
            <a:xfrm>
              <a:off x="1603008" y="128524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2" name="CasellaDiTesto 20">
              <a:extLst>
                <a:ext uri="{FF2B5EF4-FFF2-40B4-BE49-F238E27FC236}">
                  <a16:creationId xmlns:a16="http://schemas.microsoft.com/office/drawing/2014/main" id="{38FC14A1-F11D-F800-1EDB-80FC53FA313D}"/>
                </a:ext>
              </a:extLst>
            </p:cNvPr>
            <p:cNvSpPr txBox="1"/>
            <p:nvPr/>
          </p:nvSpPr>
          <p:spPr>
            <a:xfrm>
              <a:off x="3144372" y="128524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3" name="CasellaDiTesto 20">
              <a:extLst>
                <a:ext uri="{FF2B5EF4-FFF2-40B4-BE49-F238E27FC236}">
                  <a16:creationId xmlns:a16="http://schemas.microsoft.com/office/drawing/2014/main" id="{621A3F5E-A1E1-F070-57C7-3721024BE141}"/>
                </a:ext>
              </a:extLst>
            </p:cNvPr>
            <p:cNvSpPr txBox="1"/>
            <p:nvPr/>
          </p:nvSpPr>
          <p:spPr>
            <a:xfrm>
              <a:off x="4696288" y="128524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4" name="CasellaDiTesto 20">
              <a:extLst>
                <a:ext uri="{FF2B5EF4-FFF2-40B4-BE49-F238E27FC236}">
                  <a16:creationId xmlns:a16="http://schemas.microsoft.com/office/drawing/2014/main" id="{D4D13E79-7CDB-D9B3-8CE0-5A25DF807784}"/>
                </a:ext>
              </a:extLst>
            </p:cNvPr>
            <p:cNvSpPr txBox="1"/>
            <p:nvPr/>
          </p:nvSpPr>
          <p:spPr>
            <a:xfrm>
              <a:off x="6429435" y="128524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5" name="CasellaDiTesto 20">
              <a:extLst>
                <a:ext uri="{FF2B5EF4-FFF2-40B4-BE49-F238E27FC236}">
                  <a16:creationId xmlns:a16="http://schemas.microsoft.com/office/drawing/2014/main" id="{1850CEC0-3D7A-A857-EBDA-0E68AD9C7347}"/>
                </a:ext>
              </a:extLst>
            </p:cNvPr>
            <p:cNvSpPr txBox="1"/>
            <p:nvPr/>
          </p:nvSpPr>
          <p:spPr>
            <a:xfrm>
              <a:off x="7936381" y="128524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9" name="CasellaDiTesto 1">
              <a:extLst>
                <a:ext uri="{FF2B5EF4-FFF2-40B4-BE49-F238E27FC236}">
                  <a16:creationId xmlns:a16="http://schemas.microsoft.com/office/drawing/2014/main" id="{65A6CA80-6D69-5DB4-E381-E733B903A19B}"/>
                </a:ext>
              </a:extLst>
            </p:cNvPr>
            <p:cNvSpPr txBox="1"/>
            <p:nvPr/>
          </p:nvSpPr>
          <p:spPr>
            <a:xfrm>
              <a:off x="10901311" y="6416951"/>
              <a:ext cx="77510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Figure S2</a:t>
              </a:r>
              <a:endParaRPr lang="it-IT" b="1" dirty="0"/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877D521C-00B8-5823-3490-0F8F745256A8}"/>
              </a:ext>
            </a:extLst>
          </p:cNvPr>
          <p:cNvSpPr txBox="1"/>
          <p:nvPr/>
        </p:nvSpPr>
        <p:spPr>
          <a:xfrm>
            <a:off x="212570" y="3014944"/>
            <a:ext cx="11766860" cy="8281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2.  Pro-inflammatory molecules within T cells in the bone marrow and spleen of </a:t>
            </a:r>
            <a:r>
              <a:rPr lang="en-GB" sz="1100" b="1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nk3b</a:t>
            </a:r>
            <a:r>
              <a:rPr lang="en-GB" sz="1100" b="1" i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/+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b="1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nk3b</a:t>
            </a:r>
            <a:r>
              <a:rPr lang="en-GB" sz="1100" b="1" i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/- 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d </a:t>
            </a:r>
            <a:r>
              <a:rPr lang="en-GB" sz="1100" b="1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nk3b</a:t>
            </a:r>
            <a:r>
              <a:rPr lang="en-GB" sz="1100" b="1" i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/- 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Mean fluorescence intensity (MFI) of 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NF within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CD8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, and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CD4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 in the BM; MFI of TNF within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CD8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, and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CD4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 in the spleen; MFI of </a:t>
            </a:r>
            <a:r>
              <a:rPr lang="en-GB" sz="11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IFNγ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within CD4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 in the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BM and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spleen. </a:t>
            </a:r>
            <a:r>
              <a:rPr lang="en-US" sz="11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e</a:t>
            </a:r>
            <a:r>
              <a:rPr lang="en-GB" sz="11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way ANOVA, Tukey post-hoc test. 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***p&lt;0.001. n = 10-12 per group. </a:t>
            </a:r>
            <a:endParaRPr lang="it-IT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31167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21C06325-2C2D-B597-5F13-8425A66628B7}"/>
              </a:ext>
            </a:extLst>
          </p:cNvPr>
          <p:cNvGrpSpPr/>
          <p:nvPr/>
        </p:nvGrpSpPr>
        <p:grpSpPr>
          <a:xfrm>
            <a:off x="0" y="201848"/>
            <a:ext cx="18679240" cy="6656152"/>
            <a:chOff x="0" y="201848"/>
            <a:chExt cx="18679240" cy="6656152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FB9CEF90-9CE1-949D-581F-1B3F31EBDDF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92762003"/>
                </p:ext>
              </p:extLst>
            </p:nvPr>
          </p:nvGraphicFramePr>
          <p:xfrm>
            <a:off x="2416131" y="350527"/>
            <a:ext cx="2407793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3559942" imgH="3377164" progId="Prism10.Document">
                    <p:embed/>
                  </p:oleObj>
                </mc:Choice>
                <mc:Fallback>
                  <p:oleObj name="Prism 10" r:id="rId2" imgW="3559942" imgH="3377164" progId="Prism10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FB9CEF90-9CE1-949D-581F-1B3F31EBDDF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416131" y="350527"/>
                          <a:ext cx="2407793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F740E791-B54A-910A-D87A-AD8FF7AE5AA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90838618"/>
                </p:ext>
              </p:extLst>
            </p:nvPr>
          </p:nvGraphicFramePr>
          <p:xfrm>
            <a:off x="0" y="335538"/>
            <a:ext cx="2359025" cy="2282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3530771" imgH="3413540" progId="Prism10.Document">
                    <p:embed/>
                  </p:oleObj>
                </mc:Choice>
                <mc:Fallback>
                  <p:oleObj name="Prism 10" r:id="rId4" imgW="3530771" imgH="3413540" progId="Prism10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F740E791-B54A-910A-D87A-AD8FF7AE5AA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0" y="335538"/>
                          <a:ext cx="2359025" cy="2282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C9840674-5273-E7BB-8C4B-283AB7EBD08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06052564"/>
                </p:ext>
              </p:extLst>
            </p:nvPr>
          </p:nvGraphicFramePr>
          <p:xfrm>
            <a:off x="4875631" y="287430"/>
            <a:ext cx="2478513" cy="234905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3649975" imgH="3459280" progId="Prism10.Document">
                    <p:embed/>
                  </p:oleObj>
                </mc:Choice>
                <mc:Fallback>
                  <p:oleObj name="Prism 10" r:id="rId6" imgW="3649975" imgH="3459280" progId="Prism10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C9840674-5273-E7BB-8C4B-283AB7EBD08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875631" y="287430"/>
                          <a:ext cx="2478513" cy="234905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227CD914-4453-D93F-DDA6-64C536FEFDB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58996900"/>
                </p:ext>
              </p:extLst>
            </p:nvPr>
          </p:nvGraphicFramePr>
          <p:xfrm>
            <a:off x="7415480" y="393986"/>
            <a:ext cx="2478513" cy="22027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3451541" imgH="3413540" progId="Prism10.Document">
                    <p:embed/>
                  </p:oleObj>
                </mc:Choice>
                <mc:Fallback>
                  <p:oleObj name="Prism 10" r:id="rId8" imgW="3451541" imgH="3413540" progId="Prism10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227CD914-4453-D93F-DDA6-64C536FEFDB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7415480" y="393986"/>
                          <a:ext cx="2478513" cy="220270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CasellaDiTesto 20">
              <a:extLst>
                <a:ext uri="{FF2B5EF4-FFF2-40B4-BE49-F238E27FC236}">
                  <a16:creationId xmlns:a16="http://schemas.microsoft.com/office/drawing/2014/main" id="{076C1A76-6D46-B340-D167-DB193CDD2C2D}"/>
                </a:ext>
              </a:extLst>
            </p:cNvPr>
            <p:cNvSpPr txBox="1"/>
            <p:nvPr/>
          </p:nvSpPr>
          <p:spPr>
            <a:xfrm>
              <a:off x="0" y="201848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8" name="CasellaDiTesto 20">
              <a:extLst>
                <a:ext uri="{FF2B5EF4-FFF2-40B4-BE49-F238E27FC236}">
                  <a16:creationId xmlns:a16="http://schemas.microsoft.com/office/drawing/2014/main" id="{21F48FF9-20CC-E7A6-418E-2F198377D728}"/>
                </a:ext>
              </a:extLst>
            </p:cNvPr>
            <p:cNvSpPr txBox="1"/>
            <p:nvPr/>
          </p:nvSpPr>
          <p:spPr>
            <a:xfrm>
              <a:off x="2416131" y="201848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" name="CasellaDiTesto 20">
              <a:extLst>
                <a:ext uri="{FF2B5EF4-FFF2-40B4-BE49-F238E27FC236}">
                  <a16:creationId xmlns:a16="http://schemas.microsoft.com/office/drawing/2014/main" id="{97C5CCE9-C409-3B2C-31B9-57D04359D563}"/>
                </a:ext>
              </a:extLst>
            </p:cNvPr>
            <p:cNvSpPr txBox="1"/>
            <p:nvPr/>
          </p:nvSpPr>
          <p:spPr>
            <a:xfrm>
              <a:off x="4916617" y="201848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2" name="CasellaDiTesto 20">
              <a:extLst>
                <a:ext uri="{FF2B5EF4-FFF2-40B4-BE49-F238E27FC236}">
                  <a16:creationId xmlns:a16="http://schemas.microsoft.com/office/drawing/2014/main" id="{A37A7DC5-B505-53BD-9C36-81F6B8B36BC2}"/>
                </a:ext>
              </a:extLst>
            </p:cNvPr>
            <p:cNvSpPr txBox="1"/>
            <p:nvPr/>
          </p:nvSpPr>
          <p:spPr>
            <a:xfrm>
              <a:off x="7509875" y="201848"/>
              <a:ext cx="286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5" name="CasellaDiTesto 1">
              <a:extLst>
                <a:ext uri="{FF2B5EF4-FFF2-40B4-BE49-F238E27FC236}">
                  <a16:creationId xmlns:a16="http://schemas.microsoft.com/office/drawing/2014/main" id="{DDEE8B21-136E-AA35-52FF-FF68F330FB09}"/>
                </a:ext>
              </a:extLst>
            </p:cNvPr>
            <p:cNvSpPr txBox="1"/>
            <p:nvPr/>
          </p:nvSpPr>
          <p:spPr>
            <a:xfrm>
              <a:off x="10928205" y="6488668"/>
              <a:ext cx="775103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Figure S3</a:t>
              </a:r>
              <a:endParaRPr lang="it-IT" b="1" dirty="0"/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23B1524E-27EB-C8AA-D426-FC93B531F307}"/>
              </a:ext>
            </a:extLst>
          </p:cNvPr>
          <p:cNvSpPr txBox="1"/>
          <p:nvPr/>
        </p:nvSpPr>
        <p:spPr>
          <a:xfrm>
            <a:off x="37386" y="2752053"/>
            <a:ext cx="12050340" cy="8281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3.  Pro-inflammatory molecules in the PB of </a:t>
            </a:r>
            <a:r>
              <a:rPr lang="en-GB" sz="1100" b="1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nk3b</a:t>
            </a:r>
            <a:r>
              <a:rPr lang="en-GB" sz="1100" b="1" i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/+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b="1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nk3b</a:t>
            </a:r>
            <a:r>
              <a:rPr lang="en-GB" sz="1100" b="1" i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/- 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d </a:t>
            </a:r>
            <a:r>
              <a:rPr lang="en-GB" sz="1100" b="1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nk3b</a:t>
            </a:r>
            <a:r>
              <a:rPr lang="en-GB" sz="1100" b="1" i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/- 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</a:t>
            </a:r>
            <a:r>
              <a:rPr lang="en-GB" sz="1100" b="1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eated with NAC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ean fluorescence intensity (MFI) of 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TNF within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CD4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,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CD8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, and IL-6 MFI within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CD4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, and (</a:t>
            </a:r>
            <a:r>
              <a:rPr lang="en-GB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) CD8</a:t>
            </a:r>
            <a:r>
              <a:rPr lang="en-GB" sz="11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T cells in the PB of </a:t>
            </a:r>
            <a:r>
              <a:rPr lang="en-GB" sz="11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AC-treated </a:t>
            </a:r>
            <a:r>
              <a:rPr lang="en-GB" sz="11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nk3b</a:t>
            </a:r>
            <a:r>
              <a:rPr lang="en-GB" sz="1100" i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/+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</a:t>
            </a:r>
            <a:r>
              <a:rPr lang="en-GB" sz="11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nk3b</a:t>
            </a:r>
            <a:r>
              <a:rPr lang="en-GB" sz="1100" i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+/- 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d </a:t>
            </a:r>
            <a:r>
              <a:rPr lang="en-GB" sz="11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hank3b</a:t>
            </a:r>
            <a:r>
              <a:rPr lang="en-GB" sz="1100" i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-/- 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ice</a:t>
            </a:r>
            <a:r>
              <a:rPr lang="en-GB" sz="11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PBS-treated control animals. </a:t>
            </a:r>
            <a:r>
              <a:rPr lang="en-US" sz="11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GB" sz="1100" kern="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o-way ANOVA, Tukey post-hoc test. </a:t>
            </a:r>
            <a:r>
              <a:rPr lang="en-GB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*p&lt;0.05. n = 10-12 per group. </a:t>
            </a:r>
            <a:endParaRPr lang="it-IT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38219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54</Words>
  <Application>Microsoft Office PowerPoint</Application>
  <PresentationFormat>Widescreen</PresentationFormat>
  <Paragraphs>56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Aptos</vt:lpstr>
      <vt:lpstr>Arial</vt:lpstr>
      <vt:lpstr>Calibri</vt:lpstr>
      <vt:lpstr>Calibri Light</vt:lpstr>
      <vt:lpstr>Tema di Office</vt:lpstr>
      <vt:lpstr>Prism 8</vt:lpstr>
      <vt:lpstr>Prism 9</vt:lpstr>
      <vt:lpstr>Prism 10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uca Pangrazzi</dc:creator>
  <cp:lastModifiedBy>Luca Pangrazzi</cp:lastModifiedBy>
  <cp:revision>85</cp:revision>
  <dcterms:created xsi:type="dcterms:W3CDTF">2022-05-20T12:20:28Z</dcterms:created>
  <dcterms:modified xsi:type="dcterms:W3CDTF">2024-09-20T11:01:01Z</dcterms:modified>
</cp:coreProperties>
</file>